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44" autoAdjust="0"/>
    <p:restoredTop sz="94660"/>
  </p:normalViewPr>
  <p:slideViewPr>
    <p:cSldViewPr snapToGrid="0">
      <p:cViewPr varScale="1">
        <p:scale>
          <a:sx n="72" d="100"/>
          <a:sy n="72" d="100"/>
        </p:scale>
        <p:origin x="65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8CBB3-8273-47DA-9F3A-580DECBFE431}" type="datetimeFigureOut">
              <a:rPr lang="en-US" smtClean="0"/>
              <a:t>5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DE953-0AA9-4C45-965D-703881289A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27879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8CBB3-8273-47DA-9F3A-580DECBFE431}" type="datetimeFigureOut">
              <a:rPr lang="en-US" smtClean="0"/>
              <a:t>5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DE953-0AA9-4C45-965D-703881289A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9385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8CBB3-8273-47DA-9F3A-580DECBFE431}" type="datetimeFigureOut">
              <a:rPr lang="en-US" smtClean="0"/>
              <a:t>5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DE953-0AA9-4C45-965D-703881289A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24782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8CBB3-8273-47DA-9F3A-580DECBFE431}" type="datetimeFigureOut">
              <a:rPr lang="en-US" smtClean="0"/>
              <a:t>5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DE953-0AA9-4C45-965D-703881289A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08593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8CBB3-8273-47DA-9F3A-580DECBFE431}" type="datetimeFigureOut">
              <a:rPr lang="en-US" smtClean="0"/>
              <a:t>5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DE953-0AA9-4C45-965D-703881289A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09627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8CBB3-8273-47DA-9F3A-580DECBFE431}" type="datetimeFigureOut">
              <a:rPr lang="en-US" smtClean="0"/>
              <a:t>5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DE953-0AA9-4C45-965D-703881289A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21506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8CBB3-8273-47DA-9F3A-580DECBFE431}" type="datetimeFigureOut">
              <a:rPr lang="en-US" smtClean="0"/>
              <a:t>5/7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DE953-0AA9-4C45-965D-703881289A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20734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8CBB3-8273-47DA-9F3A-580DECBFE431}" type="datetimeFigureOut">
              <a:rPr lang="en-US" smtClean="0"/>
              <a:t>5/7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DE953-0AA9-4C45-965D-703881289A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02847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8CBB3-8273-47DA-9F3A-580DECBFE431}" type="datetimeFigureOut">
              <a:rPr lang="en-US" smtClean="0"/>
              <a:t>5/7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DE953-0AA9-4C45-965D-703881289A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98905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8CBB3-8273-47DA-9F3A-580DECBFE431}" type="datetimeFigureOut">
              <a:rPr lang="en-US" smtClean="0"/>
              <a:t>5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DE953-0AA9-4C45-965D-703881289A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63270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E8CBB3-8273-47DA-9F3A-580DECBFE431}" type="datetimeFigureOut">
              <a:rPr lang="en-US" smtClean="0"/>
              <a:t>5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DE953-0AA9-4C45-965D-703881289A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99710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E8CBB3-8273-47DA-9F3A-580DECBFE431}" type="datetimeFigureOut">
              <a:rPr lang="en-US" smtClean="0"/>
              <a:t>5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4DE953-0AA9-4C45-965D-703881289A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8198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9904" y="647872"/>
            <a:ext cx="8210682" cy="4389120"/>
          </a:xfrm>
        </p:spPr>
      </p:pic>
      <p:sp>
        <p:nvSpPr>
          <p:cNvPr id="6" name="Rectangle 5"/>
          <p:cNvSpPr/>
          <p:nvPr/>
        </p:nvSpPr>
        <p:spPr>
          <a:xfrm>
            <a:off x="728871" y="5036992"/>
            <a:ext cx="11065565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 Fig.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stimation of the most likely number of clusters in the germplasm panel based on the Bayesian clustering model in Structure software. 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an of Estimated Log-likelihood and the m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gnitude of delta K (</a:t>
            </a:r>
            <a:r>
              <a:rPr lang="en-US" sz="14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ΔK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were plotted against K values based  on  five independent  runs  and  K  ranging  from  1 to  10.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050037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56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bede Muleta</dc:creator>
  <cp:lastModifiedBy>Kebede Muleta</cp:lastModifiedBy>
  <cp:revision>1</cp:revision>
  <dcterms:created xsi:type="dcterms:W3CDTF">2017-05-07T23:12:02Z</dcterms:created>
  <dcterms:modified xsi:type="dcterms:W3CDTF">2017-05-07T23:16:50Z</dcterms:modified>
</cp:coreProperties>
</file>